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8640763" cy="575945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9F4933-F9F9-401B-AB47-83310067D83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33080" y="230040"/>
            <a:ext cx="7775640" cy="96048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ctr">
            <a:noAutofit/>
          </a:bodyPr>
          <a:p>
            <a:pPr indent="0" algn="ctr">
              <a:buNone/>
              <a:tabLst>
                <a:tab algn="l" pos="0"/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33080" y="1344240"/>
            <a:ext cx="7775640" cy="181332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33080" y="3330360"/>
            <a:ext cx="7775640" cy="181332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96CCF1-1FF0-43DA-8E99-F2BF86FC65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33080" y="230040"/>
            <a:ext cx="7775640" cy="96048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ctr">
            <a:noAutofit/>
          </a:bodyPr>
          <a:p>
            <a:pPr indent="0" algn="ctr">
              <a:buNone/>
              <a:tabLst>
                <a:tab algn="l" pos="0"/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33080" y="1344240"/>
            <a:ext cx="3794400" cy="181332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417560" y="1344240"/>
            <a:ext cx="3794400" cy="181332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33080" y="3330360"/>
            <a:ext cx="3794400" cy="181332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417560" y="3330360"/>
            <a:ext cx="3794400" cy="181332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D904AE-2AA6-438B-9718-D997B04B956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33080" y="230040"/>
            <a:ext cx="7775640" cy="96048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ctr">
            <a:noAutofit/>
          </a:bodyPr>
          <a:p>
            <a:pPr indent="0" algn="ctr">
              <a:buNone/>
              <a:tabLst>
                <a:tab algn="l" pos="0"/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33080" y="1344240"/>
            <a:ext cx="2503440" cy="181332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062160" y="1344240"/>
            <a:ext cx="2503440" cy="181332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691240" y="1344240"/>
            <a:ext cx="2503440" cy="181332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33080" y="3330360"/>
            <a:ext cx="2503440" cy="181332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062160" y="3330360"/>
            <a:ext cx="2503440" cy="181332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691240" y="3330360"/>
            <a:ext cx="2503440" cy="181332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F18017-AAC4-4840-8BCC-F5C8C078E15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33080" y="230040"/>
            <a:ext cx="7775640" cy="96048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ctr">
            <a:noAutofit/>
          </a:bodyPr>
          <a:p>
            <a:pPr indent="0" algn="ctr">
              <a:buNone/>
              <a:tabLst>
                <a:tab algn="l" pos="0"/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33080" y="1344240"/>
            <a:ext cx="7775640" cy="3801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49"/>
              </a:spcBef>
              <a:buNone/>
              <a:tabLst>
                <a:tab algn="l" pos="0"/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EC642C-B928-4D5C-8019-12F78279BE7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33080" y="230040"/>
            <a:ext cx="7775640" cy="96048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ctr">
            <a:noAutofit/>
          </a:bodyPr>
          <a:p>
            <a:pPr indent="0" algn="ctr">
              <a:buNone/>
              <a:tabLst>
                <a:tab algn="l" pos="0"/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33080" y="1344240"/>
            <a:ext cx="7775640" cy="380196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0BBD62-E38E-49F3-8F2A-B1B0AED8F63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33080" y="230040"/>
            <a:ext cx="7775640" cy="96048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ctr">
            <a:noAutofit/>
          </a:bodyPr>
          <a:p>
            <a:pPr indent="0" algn="ctr">
              <a:buNone/>
              <a:tabLst>
                <a:tab algn="l" pos="0"/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33080" y="1344240"/>
            <a:ext cx="3794400" cy="380196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417560" y="1344240"/>
            <a:ext cx="3794400" cy="380196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6E8C37-D25B-486F-AEDE-7C86F7A5E1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33080" y="230040"/>
            <a:ext cx="7775640" cy="96048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ctr">
            <a:noAutofit/>
          </a:bodyPr>
          <a:p>
            <a:pPr indent="0" algn="ctr">
              <a:buNone/>
              <a:tabLst>
                <a:tab algn="l" pos="0"/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EDF4E3-3373-487C-96B5-B2A1B2467BB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33080" y="230040"/>
            <a:ext cx="7775640" cy="4453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49"/>
              </a:spcBef>
              <a:tabLst>
                <a:tab algn="l" pos="0"/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E3924A-91BB-44C7-BE05-B3818CAC58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33080" y="230040"/>
            <a:ext cx="7775640" cy="96048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ctr">
            <a:noAutofit/>
          </a:bodyPr>
          <a:p>
            <a:pPr indent="0" algn="ctr">
              <a:buNone/>
              <a:tabLst>
                <a:tab algn="l" pos="0"/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33080" y="1344240"/>
            <a:ext cx="3794400" cy="181332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417560" y="1344240"/>
            <a:ext cx="3794400" cy="380196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33080" y="3330360"/>
            <a:ext cx="3794400" cy="181332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4CF600-E81D-4594-B57A-990C5B6012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33080" y="230040"/>
            <a:ext cx="7775640" cy="96048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ctr">
            <a:noAutofit/>
          </a:bodyPr>
          <a:p>
            <a:pPr indent="0" algn="ctr">
              <a:buNone/>
              <a:tabLst>
                <a:tab algn="l" pos="0"/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33080" y="1344240"/>
            <a:ext cx="3794400" cy="380196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417560" y="1344240"/>
            <a:ext cx="3794400" cy="181332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417560" y="3330360"/>
            <a:ext cx="3794400" cy="181332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EF1A58-7ED1-4FD5-ADA3-1FDB2DEC33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33080" y="230040"/>
            <a:ext cx="7775640" cy="96048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ctr">
            <a:noAutofit/>
          </a:bodyPr>
          <a:p>
            <a:pPr indent="0" algn="ctr">
              <a:buNone/>
              <a:tabLst>
                <a:tab algn="l" pos="0"/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33080" y="1344240"/>
            <a:ext cx="3794400" cy="181332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417560" y="1344240"/>
            <a:ext cx="3794400" cy="181332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33080" y="3330360"/>
            <a:ext cx="7775640" cy="181332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793208-8FFF-453C-9D63-0E101DB922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33080" y="230040"/>
            <a:ext cx="7775640" cy="96048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ctr">
            <a:noAutofit/>
          </a:bodyPr>
          <a:p>
            <a:pPr indent="0" algn="ctr">
              <a:buNone/>
              <a:tabLst>
                <a:tab algn="l" pos="0"/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33080" y="1344240"/>
            <a:ext cx="7775640" cy="380196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t">
            <a:normAutofit/>
          </a:bodyPr>
          <a:p>
            <a:pPr marL="277920" indent="-277920">
              <a:spcBef>
                <a:spcPts val="649"/>
              </a:spcBef>
              <a:buClr>
                <a:srgbClr val="000000"/>
              </a:buClr>
              <a:buFont typeface="Arial"/>
              <a:buChar char="•"/>
              <a:tabLst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1" marL="601560" indent="-231840">
              <a:spcBef>
                <a:spcPts val="649"/>
              </a:spcBef>
              <a:buClr>
                <a:srgbClr val="000000"/>
              </a:buClr>
              <a:buFont typeface="Arial"/>
              <a:buChar char="–"/>
              <a:tabLst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2" marL="925560" indent="-184320">
              <a:spcBef>
                <a:spcPts val="649"/>
              </a:spcBef>
              <a:buClr>
                <a:srgbClr val="000000"/>
              </a:buClr>
              <a:buFont typeface="Arial"/>
              <a:buChar char="•"/>
              <a:tabLst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3" marL="1295280" indent="-183960">
              <a:spcBef>
                <a:spcPts val="649"/>
              </a:spcBef>
              <a:buClr>
                <a:srgbClr val="000000"/>
              </a:buClr>
              <a:buFont typeface="Arial"/>
              <a:buChar char="–"/>
              <a:tabLst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4" marL="1666800" indent="-185760">
              <a:spcBef>
                <a:spcPts val="649"/>
              </a:spcBef>
              <a:buClr>
                <a:srgbClr val="000000"/>
              </a:buClr>
              <a:buFont typeface="Arial"/>
              <a:buChar char="»"/>
              <a:tabLst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5" marL="1666800" indent="-185760">
              <a:spcBef>
                <a:spcPts val="649"/>
              </a:spcBef>
              <a:buClr>
                <a:srgbClr val="000000"/>
              </a:buClr>
              <a:buFont typeface="Arial"/>
              <a:buChar char="»"/>
              <a:tabLst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6" marL="1666800" indent="-185760">
              <a:spcBef>
                <a:spcPts val="649"/>
              </a:spcBef>
              <a:buClr>
                <a:srgbClr val="000000"/>
              </a:buClr>
              <a:buFont typeface="Arial"/>
              <a:buChar char="»"/>
              <a:tabLst>
                <a:tab algn="l" pos="741240"/>
                <a:tab algn="l" pos="1482840"/>
                <a:tab algn="l" pos="2224080"/>
                <a:tab algn="l" pos="2965320"/>
                <a:tab algn="l" pos="3706920"/>
                <a:tab algn="l" pos="4448160"/>
                <a:tab algn="l" pos="5189400"/>
                <a:tab algn="l" pos="5931000"/>
                <a:tab algn="l" pos="6672240"/>
                <a:tab algn="l" pos="7413480"/>
                <a:tab algn="l" pos="8155080"/>
                <a:tab algn="l" pos="8896320"/>
                <a:tab algn="l" pos="9637560"/>
                <a:tab algn="l" pos="1037916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33440" y="5246280"/>
            <a:ext cx="2014560" cy="39852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952720" y="5246280"/>
            <a:ext cx="2735280" cy="39852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192360" y="5246280"/>
            <a:ext cx="2016360" cy="398520"/>
          </a:xfrm>
          <a:prstGeom prst="rect">
            <a:avLst/>
          </a:prstGeom>
          <a:noFill/>
          <a:ln w="0">
            <a:noFill/>
          </a:ln>
        </p:spPr>
        <p:txBody>
          <a:bodyPr lIns="74160" rIns="74160" tIns="37080" bIns="3708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5031B03-B90F-4AD3-99E7-38CA67EB3A39}" type="slidenum">
              <a:rPr b="0" lang="en-US" sz="11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7" descr=""/>
          <p:cNvPicPr/>
          <p:nvPr/>
        </p:nvPicPr>
        <p:blipFill>
          <a:blip r:embed="rId1"/>
          <a:stretch/>
        </p:blipFill>
        <p:spPr>
          <a:xfrm>
            <a:off x="0" y="-106200"/>
            <a:ext cx="8043840" cy="5870520"/>
          </a:xfrm>
          <a:prstGeom prst="rect">
            <a:avLst/>
          </a:prstGeom>
          <a:ln w="0">
            <a:noFill/>
          </a:ln>
        </p:spPr>
      </p:pic>
      <p:sp>
        <p:nvSpPr>
          <p:cNvPr id="42" name="TextBox 21"/>
          <p:cNvSpPr/>
          <p:nvPr/>
        </p:nvSpPr>
        <p:spPr>
          <a:xfrm>
            <a:off x="4112640" y="19080"/>
            <a:ext cx="266616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63768390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naeromyxobacter sp. 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22"/>
          <p:cNvSpPr/>
          <p:nvPr/>
        </p:nvSpPr>
        <p:spPr>
          <a:xfrm>
            <a:off x="4133520" y="298440"/>
            <a:ext cx="319500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6158649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naeromyxobacter dehalogenan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23"/>
          <p:cNvSpPr/>
          <p:nvPr/>
        </p:nvSpPr>
        <p:spPr>
          <a:xfrm>
            <a:off x="4015800" y="625320"/>
            <a:ext cx="266652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9996565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Geobacter sulfurreducen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24"/>
          <p:cNvSpPr/>
          <p:nvPr/>
        </p:nvSpPr>
        <p:spPr>
          <a:xfrm>
            <a:off x="4338720" y="892080"/>
            <a:ext cx="273348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78222571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Geobacter metallireducen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25"/>
          <p:cNvSpPr/>
          <p:nvPr/>
        </p:nvSpPr>
        <p:spPr>
          <a:xfrm>
            <a:off x="4326840" y="1190520"/>
            <a:ext cx="293004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48264248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Geobacter uraniumreducen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26"/>
          <p:cNvSpPr/>
          <p:nvPr/>
        </p:nvSpPr>
        <p:spPr>
          <a:xfrm>
            <a:off x="4391280" y="1461960"/>
            <a:ext cx="217260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18745385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Geobacter lovley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27"/>
          <p:cNvSpPr/>
          <p:nvPr/>
        </p:nvSpPr>
        <p:spPr>
          <a:xfrm>
            <a:off x="3809880" y="1789200"/>
            <a:ext cx="223668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1396513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 Chlorobium limico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28"/>
          <p:cNvSpPr/>
          <p:nvPr/>
        </p:nvSpPr>
        <p:spPr>
          <a:xfrm>
            <a:off x="4015440" y="2065320"/>
            <a:ext cx="227340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1673190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 Chlorobium tepidu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29"/>
          <p:cNvSpPr/>
          <p:nvPr/>
        </p:nvSpPr>
        <p:spPr>
          <a:xfrm>
            <a:off x="3958200" y="2343240"/>
            <a:ext cx="276408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78189373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 Chlorobium chlorochromati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30"/>
          <p:cNvSpPr/>
          <p:nvPr/>
        </p:nvSpPr>
        <p:spPr>
          <a:xfrm>
            <a:off x="3938040" y="2619360"/>
            <a:ext cx="307476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19356515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Chlorobium phaeobacteroide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31"/>
          <p:cNvSpPr/>
          <p:nvPr/>
        </p:nvSpPr>
        <p:spPr>
          <a:xfrm>
            <a:off x="5816520" y="2930400"/>
            <a:ext cx="287820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95931334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Desulfuromonas acetoxidan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32"/>
          <p:cNvSpPr/>
          <p:nvPr/>
        </p:nvSpPr>
        <p:spPr>
          <a:xfrm>
            <a:off x="5881680" y="3218040"/>
            <a:ext cx="238608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94263151 delta proteobacteriu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33"/>
          <p:cNvSpPr/>
          <p:nvPr/>
        </p:nvSpPr>
        <p:spPr>
          <a:xfrm>
            <a:off x="3375000" y="3516480"/>
            <a:ext cx="326664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3016634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Magnetospirillum magnetotacticu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34"/>
          <p:cNvSpPr/>
          <p:nvPr/>
        </p:nvSpPr>
        <p:spPr>
          <a:xfrm>
            <a:off x="3279960" y="3792600"/>
            <a:ext cx="326664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3309706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Magnetospirillum magnetotacticu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35"/>
          <p:cNvSpPr/>
          <p:nvPr/>
        </p:nvSpPr>
        <p:spPr>
          <a:xfrm>
            <a:off x="3122280" y="4070520"/>
            <a:ext cx="240264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7155876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zotobacter vinelandi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36"/>
          <p:cNvSpPr/>
          <p:nvPr/>
        </p:nvSpPr>
        <p:spPr>
          <a:xfrm>
            <a:off x="3390480" y="4370400"/>
            <a:ext cx="182196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6372846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Vibrio fischer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37"/>
          <p:cNvSpPr/>
          <p:nvPr/>
        </p:nvSpPr>
        <p:spPr>
          <a:xfrm>
            <a:off x="2945880" y="4657680"/>
            <a:ext cx="192564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5641164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Vibrio cholera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38"/>
          <p:cNvSpPr/>
          <p:nvPr/>
        </p:nvSpPr>
        <p:spPr>
          <a:xfrm>
            <a:off x="2836080" y="4935600"/>
            <a:ext cx="254592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53837316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Vibrio parahaemolytic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7-10T16:23:57Z</dcterms:created>
  <dc:creator>GB</dc:creator>
  <dc:description/>
  <dc:language>en-US</dc:language>
  <cp:lastModifiedBy> </cp:lastModifiedBy>
  <dcterms:modified xsi:type="dcterms:W3CDTF">2009-01-08T11:26:34Z</dcterms:modified>
  <cp:revision>8</cp:revision>
  <dc:subject/>
  <dc:title>Slide 1</dc:title>
</cp:coreProperties>
</file>